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9EFA90-E6F9-4EE5-A390-69C585B6CE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677E99-2E6A-4F44-B756-C46ABA30ED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E73063-0E69-40FE-B58F-EF1BD4641C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B5EC0-E6F2-4C71-8F28-E4822AF60F9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5AEA5-6CAA-461E-9486-54BE16135D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3975A3-FEE1-4778-898B-93F40D1BB8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AD4E8F-62BB-4451-9F8C-CABBD3C149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834DA-6158-4100-9C56-6E1955C67C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3CF359-CADE-4584-8D4E-1690D02050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99BED-127D-4AC7-966E-21D1A284E3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7B311A-8CA9-4C91-932E-B3281C6592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A0940C-28DC-4394-89AD-6B87A2D847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A42066-FF8C-46B6-9D4E-2F8FF124C5A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2"/>
          <p:cNvSpPr/>
          <p:nvPr/>
        </p:nvSpPr>
        <p:spPr>
          <a:xfrm>
            <a:off x="2247840" y="2279520"/>
            <a:ext cx="1800" cy="21132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3"/>
          <p:cNvGrpSpPr/>
          <p:nvPr/>
        </p:nvGrpSpPr>
        <p:grpSpPr>
          <a:xfrm>
            <a:off x="1700280" y="366840"/>
            <a:ext cx="1081440" cy="1965600"/>
            <a:chOff x="1700280" y="366840"/>
            <a:chExt cx="1081440" cy="1965600"/>
          </a:xfrm>
        </p:grpSpPr>
        <p:cxnSp>
          <p:nvCxnSpPr>
            <p:cNvPr id="43" name="AutoShape 4"/>
            <p:cNvCxnSpPr>
              <a:stCxn id="44" idx="0"/>
              <a:endCxn id="45" idx="2"/>
            </p:cNvCxnSpPr>
            <p:nvPr/>
          </p:nvCxnSpPr>
          <p:spPr>
            <a:xfrm flipV="1">
              <a:off x="2008080" y="613080"/>
              <a:ext cx="141840" cy="20160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headEnd len="sm" type="triangle" w="sm"/>
            </a:ln>
          </p:spPr>
        </p:cxnSp>
        <p:sp>
          <p:nvSpPr>
            <p:cNvPr id="45" name="Text Box 5"/>
            <p:cNvSpPr/>
            <p:nvPr/>
          </p:nvSpPr>
          <p:spPr>
            <a:xfrm>
              <a:off x="1700280" y="366840"/>
              <a:ext cx="898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R64 x 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R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"/>
            <p:cNvSpPr/>
            <p:nvPr/>
          </p:nvSpPr>
          <p:spPr>
            <a:xfrm>
              <a:off x="1864440" y="814320"/>
              <a:ext cx="2876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7"/>
            <p:cNvSpPr/>
            <p:nvPr/>
          </p:nvSpPr>
          <p:spPr>
            <a:xfrm>
              <a:off x="2012400" y="814320"/>
              <a:ext cx="53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x IR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7" name="AutoShape 8"/>
            <p:cNvCxnSpPr>
              <a:stCxn id="48" idx="0"/>
            </p:cNvCxnSpPr>
            <p:nvPr/>
          </p:nvCxnSpPr>
          <p:spPr>
            <a:xfrm flipH="1" flipV="1">
              <a:off x="2133360" y="1015200"/>
              <a:ext cx="3240" cy="1882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headEnd len="sm" type="triangle" w="sm"/>
            </a:ln>
          </p:spPr>
        </p:cxnSp>
        <p:sp>
          <p:nvSpPr>
            <p:cNvPr id="48" name="Rectangle 9"/>
            <p:cNvSpPr/>
            <p:nvPr/>
          </p:nvSpPr>
          <p:spPr>
            <a:xfrm>
              <a:off x="1890360" y="1203120"/>
              <a:ext cx="4921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C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0"/>
            <p:cNvSpPr/>
            <p:nvPr/>
          </p:nvSpPr>
          <p:spPr>
            <a:xfrm>
              <a:off x="2250360" y="1203120"/>
              <a:ext cx="53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x IR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0" name="AutoShape 11"/>
            <p:cNvCxnSpPr>
              <a:stCxn id="51" idx="0"/>
            </p:cNvCxnSpPr>
            <p:nvPr/>
          </p:nvCxnSpPr>
          <p:spPr>
            <a:xfrm flipV="1">
              <a:off x="2212560" y="1447200"/>
              <a:ext cx="144720" cy="1594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headEnd len="sm" type="triangle" w="sm"/>
            </a:ln>
          </p:spPr>
        </p:cxnSp>
        <p:sp>
          <p:nvSpPr>
            <p:cNvPr id="51" name="Rectangle 12"/>
            <p:cNvSpPr/>
            <p:nvPr/>
          </p:nvSpPr>
          <p:spPr>
            <a:xfrm>
              <a:off x="1966680" y="1606320"/>
              <a:ext cx="4921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C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2" name="AutoShape 13"/>
            <p:cNvCxnSpPr>
              <a:stCxn id="53" idx="0"/>
              <a:endCxn id="51" idx="2"/>
            </p:cNvCxnSpPr>
            <p:nvPr/>
          </p:nvCxnSpPr>
          <p:spPr>
            <a:xfrm flipH="1" flipV="1">
              <a:off x="2212560" y="1873440"/>
              <a:ext cx="6840" cy="19224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headEnd len="sm" type="triangle" w="sm"/>
            </a:ln>
          </p:spPr>
        </p:cxnSp>
        <p:sp>
          <p:nvSpPr>
            <p:cNvPr id="53" name="Rectangle 14"/>
            <p:cNvSpPr/>
            <p:nvPr/>
          </p:nvSpPr>
          <p:spPr>
            <a:xfrm>
              <a:off x="1973160" y="2065320"/>
              <a:ext cx="4921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C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Oval 15"/>
            <p:cNvSpPr/>
            <p:nvPr/>
          </p:nvSpPr>
          <p:spPr>
            <a:xfrm>
              <a:off x="2020680" y="1884240"/>
              <a:ext cx="109800" cy="1044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7360" bIns="273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Rectangle 55"/>
          <p:cNvSpPr/>
          <p:nvPr/>
        </p:nvSpPr>
        <p:spPr>
          <a:xfrm>
            <a:off x="885960" y="2487600"/>
            <a:ext cx="5116320" cy="457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creened under 2 types of severe drought, resulting in 150 survival Drought Tolerance (DT) BC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ntrogression lines (ILs), which were genotyped with SSR marker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76"/>
          <p:cNvSpPr/>
          <p:nvPr/>
        </p:nvSpPr>
        <p:spPr>
          <a:xfrm>
            <a:off x="644400" y="4484520"/>
            <a:ext cx="5459400" cy="36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creened under severe drought at the reproductive stage and 90 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plants survived the stress which wer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rogeny tested under both stress and control conditions and genotyped with polymorphic SSR marker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Group 102"/>
          <p:cNvGrpSpPr/>
          <p:nvPr/>
        </p:nvGrpSpPr>
        <p:grpSpPr>
          <a:xfrm>
            <a:off x="2503800" y="3059280"/>
            <a:ext cx="1678680" cy="1380600"/>
            <a:chOff x="2503800" y="3059280"/>
            <a:chExt cx="1678680" cy="1380600"/>
          </a:xfrm>
        </p:grpSpPr>
        <p:sp>
          <p:nvSpPr>
            <p:cNvPr id="58" name="Text Box 60"/>
            <p:cNvSpPr/>
            <p:nvPr/>
          </p:nvSpPr>
          <p:spPr>
            <a:xfrm>
              <a:off x="2503800" y="3059280"/>
              <a:ext cx="167868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L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(DGI 74) x IL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 (DGI 187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61"/>
            <p:cNvSpPr/>
            <p:nvPr/>
          </p:nvSpPr>
          <p:spPr>
            <a:xfrm>
              <a:off x="3325680" y="3306960"/>
              <a:ext cx="1440" cy="190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62"/>
            <p:cNvSpPr/>
            <p:nvPr/>
          </p:nvSpPr>
          <p:spPr>
            <a:xfrm>
              <a:off x="3200760" y="3486600"/>
              <a:ext cx="2876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63"/>
            <p:cNvSpPr/>
            <p:nvPr/>
          </p:nvSpPr>
          <p:spPr>
            <a:xfrm>
              <a:off x="3336840" y="3752280"/>
              <a:ext cx="1440" cy="237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64"/>
            <p:cNvSpPr/>
            <p:nvPr/>
          </p:nvSpPr>
          <p:spPr>
            <a:xfrm>
              <a:off x="3211920" y="3980880"/>
              <a:ext cx="2876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Oval 72"/>
            <p:cNvSpPr/>
            <p:nvPr/>
          </p:nvSpPr>
          <p:spPr>
            <a:xfrm>
              <a:off x="3184200" y="3771360"/>
              <a:ext cx="128880" cy="11412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4200" bIns="342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X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74"/>
            <p:cNvSpPr/>
            <p:nvPr/>
          </p:nvSpPr>
          <p:spPr>
            <a:xfrm>
              <a:off x="3348000" y="4238280"/>
              <a:ext cx="1440" cy="201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Group 28"/>
          <p:cNvGrpSpPr/>
          <p:nvPr/>
        </p:nvGrpSpPr>
        <p:grpSpPr>
          <a:xfrm>
            <a:off x="3716280" y="324000"/>
            <a:ext cx="1100880" cy="1965600"/>
            <a:chOff x="3716280" y="324000"/>
            <a:chExt cx="1100880" cy="1965600"/>
          </a:xfrm>
        </p:grpSpPr>
        <p:cxnSp>
          <p:nvCxnSpPr>
            <p:cNvPr id="66" name="AutoShape 29"/>
            <p:cNvCxnSpPr>
              <a:stCxn id="67" idx="0"/>
              <a:endCxn id="68" idx="2"/>
            </p:cNvCxnSpPr>
            <p:nvPr/>
          </p:nvCxnSpPr>
          <p:spPr>
            <a:xfrm flipV="1">
              <a:off x="4029840" y="570240"/>
              <a:ext cx="152280" cy="20160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headEnd len="sm" type="triangle" w="sm"/>
            </a:ln>
          </p:spPr>
        </p:cxnSp>
        <p:sp>
          <p:nvSpPr>
            <p:cNvPr id="68" name="Text Box 30"/>
            <p:cNvSpPr/>
            <p:nvPr/>
          </p:nvSpPr>
          <p:spPr>
            <a:xfrm>
              <a:off x="3716280" y="324000"/>
              <a:ext cx="93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R64 x 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ina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31"/>
            <p:cNvSpPr/>
            <p:nvPr/>
          </p:nvSpPr>
          <p:spPr>
            <a:xfrm>
              <a:off x="3886200" y="771480"/>
              <a:ext cx="2876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32"/>
            <p:cNvSpPr/>
            <p:nvPr/>
          </p:nvSpPr>
          <p:spPr>
            <a:xfrm>
              <a:off x="4039200" y="771480"/>
              <a:ext cx="53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x IR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0" name="AutoShape 33"/>
            <p:cNvCxnSpPr>
              <a:stCxn id="71" idx="0"/>
            </p:cNvCxnSpPr>
            <p:nvPr/>
          </p:nvCxnSpPr>
          <p:spPr>
            <a:xfrm flipV="1">
              <a:off x="4159080" y="972360"/>
              <a:ext cx="6120" cy="1882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headEnd len="sm" type="triangle" w="sm"/>
            </a:ln>
          </p:spPr>
        </p:cxnSp>
        <p:sp>
          <p:nvSpPr>
            <p:cNvPr id="71" name="Rectangle 34"/>
            <p:cNvSpPr/>
            <p:nvPr/>
          </p:nvSpPr>
          <p:spPr>
            <a:xfrm>
              <a:off x="3913200" y="1160280"/>
              <a:ext cx="4921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C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35"/>
            <p:cNvSpPr/>
            <p:nvPr/>
          </p:nvSpPr>
          <p:spPr>
            <a:xfrm>
              <a:off x="4285800" y="1160280"/>
              <a:ext cx="53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x IR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3" name="AutoShape 36"/>
            <p:cNvCxnSpPr>
              <a:stCxn id="74" idx="0"/>
            </p:cNvCxnSpPr>
            <p:nvPr/>
          </p:nvCxnSpPr>
          <p:spPr>
            <a:xfrm flipV="1">
              <a:off x="4237560" y="1404360"/>
              <a:ext cx="159480" cy="1594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headEnd len="sm" type="triangle" w="sm"/>
            </a:ln>
          </p:spPr>
        </p:cxnSp>
        <p:sp>
          <p:nvSpPr>
            <p:cNvPr id="74" name="Rectangle 37"/>
            <p:cNvSpPr/>
            <p:nvPr/>
          </p:nvSpPr>
          <p:spPr>
            <a:xfrm>
              <a:off x="3991680" y="1563480"/>
              <a:ext cx="4921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C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5" name="AutoShape 38"/>
            <p:cNvCxnSpPr>
              <a:stCxn id="76" idx="0"/>
              <a:endCxn id="74" idx="2"/>
            </p:cNvCxnSpPr>
            <p:nvPr/>
          </p:nvCxnSpPr>
          <p:spPr>
            <a:xfrm flipH="1" flipV="1">
              <a:off x="4237560" y="1830600"/>
              <a:ext cx="7200" cy="19224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headEnd len="sm" type="triangle" w="sm"/>
            </a:ln>
          </p:spPr>
        </p:cxnSp>
        <p:sp>
          <p:nvSpPr>
            <p:cNvPr id="76" name="Rectangle 39"/>
            <p:cNvSpPr/>
            <p:nvPr/>
          </p:nvSpPr>
          <p:spPr>
            <a:xfrm>
              <a:off x="3998520" y="2022480"/>
              <a:ext cx="4921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C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Oval 40"/>
            <p:cNvSpPr/>
            <p:nvPr/>
          </p:nvSpPr>
          <p:spPr>
            <a:xfrm>
              <a:off x="4048200" y="1841400"/>
              <a:ext cx="113760" cy="1044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7360" bIns="273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Line 2"/>
          <p:cNvSpPr/>
          <p:nvPr/>
        </p:nvSpPr>
        <p:spPr>
          <a:xfrm>
            <a:off x="4292640" y="2268360"/>
            <a:ext cx="1440" cy="21276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0"/>
          <p:cNvSpPr/>
          <p:nvPr/>
        </p:nvSpPr>
        <p:spPr>
          <a:xfrm>
            <a:off x="2276640" y="2916360"/>
            <a:ext cx="576000" cy="215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41"/>
          <p:cNvSpPr/>
          <p:nvPr/>
        </p:nvSpPr>
        <p:spPr>
          <a:xfrm flipH="1">
            <a:off x="3789000" y="2916360"/>
            <a:ext cx="431640" cy="215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2"/>
          <p:cNvSpPr/>
          <p:nvPr/>
        </p:nvSpPr>
        <p:spPr>
          <a:xfrm>
            <a:off x="3357720" y="4859280"/>
            <a:ext cx="0" cy="219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3"/>
          <p:cNvSpPr/>
          <p:nvPr/>
        </p:nvSpPr>
        <p:spPr>
          <a:xfrm>
            <a:off x="1527120" y="5110200"/>
            <a:ext cx="37213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One of the survival 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plants,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DK15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(98% homozygosit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86"/>
          <p:cNvSpPr/>
          <p:nvPr/>
        </p:nvSpPr>
        <p:spPr>
          <a:xfrm>
            <a:off x="461880" y="5880240"/>
            <a:ext cx="6167520" cy="103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81080" indent="-181080"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Times New Roman"/>
              </a:rPr>
              <a:t>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 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The BC breeding and intercross procedures for developing drought tolerant introgression lines (DGI 74 and DGI187) and the pyramiding line, DK151 using IR64 (the recipient) and 2 donors, BR24 and Binam. The two types of drought stress for screening the B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populations included the lowland drought at the reproductive stage and the chronic drought under the upland conditio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Binying Fu</cp:lastModifiedBy>
  <dcterms:modified xsi:type="dcterms:W3CDTF">2011-03-09T06:09:00Z</dcterms:modified>
  <cp:revision>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